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924" y="-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6002704"/>
            <a:ext cx="864096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</a:t>
            </a:r>
            <a:r>
              <a:rPr lang="fr-FR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fr-FR" sz="1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 of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atur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153T45 as N1-méthyl-2-pyridone-5-carboxamide (cas 701-44-0);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standard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lecu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u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p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ull 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d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ull 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ttom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S/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96173" y="260648"/>
            <a:ext cx="675165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96173" y="2276872"/>
            <a:ext cx="675165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96173" y="4149280"/>
            <a:ext cx="675165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39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Gaelle</dc:creator>
  <cp:lastModifiedBy>GRISON Stephane</cp:lastModifiedBy>
  <cp:revision>7</cp:revision>
  <dcterms:created xsi:type="dcterms:W3CDTF">2014-11-17T10:21:09Z</dcterms:created>
  <dcterms:modified xsi:type="dcterms:W3CDTF">2016-07-07T13:30:50Z</dcterms:modified>
</cp:coreProperties>
</file>